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7EA1D9-189F-4B63-915C-BBA0203FDFF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FA5073-AED0-48DB-9EC2-9F3A525F5E0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D1451C-5C0F-4290-B374-3B4584A3CDC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D0986C-7A8A-4FAD-A2E5-1F51712D2DD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231153-1BFA-4241-938D-3CA74D1A2F3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4D5B81-56FE-4ECB-A737-814C9973865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55DC84-59E8-48B7-85AD-86389029151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CFED72-5882-4C11-9C7F-2C3D6689901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AA21FB-5ED7-4BC3-956A-5819B072B0C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FBD0C6-C9A8-4217-AF96-853520B799B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2BA3B5-FFE9-44DC-B1C9-D6A854CF888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75A434-EB84-4472-82F1-EF7D8819F60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C748923-E652-4865-9770-C0EDA38C378C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1128600" y="614160"/>
            <a:ext cx="3782160" cy="5839200"/>
            <a:chOff x="1128600" y="614160"/>
            <a:chExt cx="3782160" cy="5839200"/>
          </a:xfrm>
        </p:grpSpPr>
        <p:sp>
          <p:nvSpPr>
            <p:cNvPr id="42" name=""/>
            <p:cNvSpPr/>
            <p:nvPr/>
          </p:nvSpPr>
          <p:spPr>
            <a:xfrm>
              <a:off x="1128600" y="4976640"/>
              <a:ext cx="16164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"/>
            <p:cNvSpPr/>
            <p:nvPr/>
          </p:nvSpPr>
          <p:spPr>
            <a:xfrm flipV="1">
              <a:off x="1290240" y="794880"/>
              <a:ext cx="0" cy="418140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1290240" y="795240"/>
              <a:ext cx="164808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 flipV="1">
              <a:off x="2938320" y="680760"/>
              <a:ext cx="0" cy="11448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2938320" y="680760"/>
              <a:ext cx="84780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2938320" y="795240"/>
              <a:ext cx="0" cy="9540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2938320" y="890640"/>
              <a:ext cx="30456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 flipV="1">
              <a:off x="1290240" y="2109600"/>
              <a:ext cx="0" cy="28670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1290240" y="2109600"/>
              <a:ext cx="5724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 flipV="1">
              <a:off x="1347480" y="1090080"/>
              <a:ext cx="0" cy="101916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1347480" y="1090440"/>
              <a:ext cx="61920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1347480" y="2109600"/>
              <a:ext cx="0" cy="18108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1347480" y="2290680"/>
              <a:ext cx="6660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 flipV="1">
              <a:off x="1414080" y="1385640"/>
              <a:ext cx="0" cy="9050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1414080" y="1385640"/>
              <a:ext cx="1908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 flipV="1">
              <a:off x="1433160" y="1290600"/>
              <a:ext cx="0" cy="950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1433160" y="1290600"/>
              <a:ext cx="57168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1433160" y="1385640"/>
              <a:ext cx="0" cy="11448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1433160" y="1500120"/>
              <a:ext cx="76212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1414080" y="2290680"/>
              <a:ext cx="0" cy="152388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1414080" y="3814560"/>
              <a:ext cx="10476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 flipV="1">
              <a:off x="1518840" y="1699920"/>
              <a:ext cx="0" cy="211428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1518840" y="1700280"/>
              <a:ext cx="160020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1518840" y="3814560"/>
              <a:ext cx="0" cy="98100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1518840" y="4795560"/>
              <a:ext cx="61920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 flipV="1">
              <a:off x="2138040" y="4290840"/>
              <a:ext cx="0" cy="50472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2138040" y="4290840"/>
              <a:ext cx="2880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 flipV="1">
              <a:off x="2166840" y="3681000"/>
              <a:ext cx="0" cy="60948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2166840" y="3681360"/>
              <a:ext cx="1908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 flipV="1">
              <a:off x="2185920" y="3233520"/>
              <a:ext cx="0" cy="4478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2185920" y="3233520"/>
              <a:ext cx="7596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 flipV="1">
              <a:off x="2261880" y="2814480"/>
              <a:ext cx="0" cy="4190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2261880" y="2814480"/>
              <a:ext cx="972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 flipV="1">
              <a:off x="2271600" y="2461680"/>
              <a:ext cx="0" cy="3524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2271600" y="2462040"/>
              <a:ext cx="7596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 flipV="1">
              <a:off x="2347560" y="2090520"/>
              <a:ext cx="0" cy="37152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2347560" y="2090520"/>
              <a:ext cx="18108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 flipV="1">
              <a:off x="2528640" y="1899720"/>
              <a:ext cx="0" cy="1904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2528640" y="1900080"/>
              <a:ext cx="6660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2528640" y="2090520"/>
              <a:ext cx="0" cy="18108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2528640" y="2271600"/>
              <a:ext cx="3816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 flipV="1">
              <a:off x="2566800" y="2109600"/>
              <a:ext cx="0" cy="16200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2566800" y="2109600"/>
              <a:ext cx="17136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2566800" y="2271600"/>
              <a:ext cx="0" cy="14292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2566800" y="2414520"/>
              <a:ext cx="936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 flipV="1">
              <a:off x="2576160" y="2309400"/>
              <a:ext cx="0" cy="10476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2576160" y="2309760"/>
              <a:ext cx="2880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2576160" y="2414520"/>
              <a:ext cx="0" cy="950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"/>
            <p:cNvSpPr/>
            <p:nvPr/>
          </p:nvSpPr>
          <p:spPr>
            <a:xfrm>
              <a:off x="2576160" y="2509560"/>
              <a:ext cx="3816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"/>
            <p:cNvSpPr/>
            <p:nvPr/>
          </p:nvSpPr>
          <p:spPr>
            <a:xfrm>
              <a:off x="2347560" y="2462040"/>
              <a:ext cx="0" cy="3524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"/>
            <p:cNvSpPr/>
            <p:nvPr/>
          </p:nvSpPr>
          <p:spPr>
            <a:xfrm>
              <a:off x="2347560" y="2814480"/>
              <a:ext cx="11448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"/>
            <p:cNvSpPr/>
            <p:nvPr/>
          </p:nvSpPr>
          <p:spPr>
            <a:xfrm flipV="1">
              <a:off x="2462040" y="2719440"/>
              <a:ext cx="0" cy="950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"/>
            <p:cNvSpPr/>
            <p:nvPr/>
          </p:nvSpPr>
          <p:spPr>
            <a:xfrm>
              <a:off x="2462040" y="2719440"/>
              <a:ext cx="5724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"/>
            <p:cNvSpPr/>
            <p:nvPr/>
          </p:nvSpPr>
          <p:spPr>
            <a:xfrm>
              <a:off x="2462040" y="2814480"/>
              <a:ext cx="0" cy="10476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"/>
            <p:cNvSpPr/>
            <p:nvPr/>
          </p:nvSpPr>
          <p:spPr>
            <a:xfrm>
              <a:off x="2462040" y="2919240"/>
              <a:ext cx="11412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"/>
            <p:cNvSpPr/>
            <p:nvPr/>
          </p:nvSpPr>
          <p:spPr>
            <a:xfrm>
              <a:off x="2271600" y="2814480"/>
              <a:ext cx="0" cy="40968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"/>
            <p:cNvSpPr/>
            <p:nvPr/>
          </p:nvSpPr>
          <p:spPr>
            <a:xfrm>
              <a:off x="2271600" y="3224160"/>
              <a:ext cx="26640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"/>
            <p:cNvSpPr/>
            <p:nvPr/>
          </p:nvSpPr>
          <p:spPr>
            <a:xfrm flipV="1">
              <a:off x="2538000" y="3119040"/>
              <a:ext cx="0" cy="10476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"/>
            <p:cNvSpPr/>
            <p:nvPr/>
          </p:nvSpPr>
          <p:spPr>
            <a:xfrm>
              <a:off x="2538000" y="3119400"/>
              <a:ext cx="5724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"/>
            <p:cNvSpPr/>
            <p:nvPr/>
          </p:nvSpPr>
          <p:spPr>
            <a:xfrm>
              <a:off x="2538000" y="3224160"/>
              <a:ext cx="0" cy="10476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"/>
            <p:cNvSpPr/>
            <p:nvPr/>
          </p:nvSpPr>
          <p:spPr>
            <a:xfrm>
              <a:off x="2538000" y="3328920"/>
              <a:ext cx="5724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"/>
            <p:cNvSpPr/>
            <p:nvPr/>
          </p:nvSpPr>
          <p:spPr>
            <a:xfrm>
              <a:off x="2261880" y="3233520"/>
              <a:ext cx="0" cy="45720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"/>
            <p:cNvSpPr/>
            <p:nvPr/>
          </p:nvSpPr>
          <p:spPr>
            <a:xfrm>
              <a:off x="2261880" y="3690720"/>
              <a:ext cx="11448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"/>
            <p:cNvSpPr/>
            <p:nvPr/>
          </p:nvSpPr>
          <p:spPr>
            <a:xfrm flipV="1">
              <a:off x="2376360" y="3528720"/>
              <a:ext cx="0" cy="1616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"/>
            <p:cNvSpPr/>
            <p:nvPr/>
          </p:nvSpPr>
          <p:spPr>
            <a:xfrm>
              <a:off x="2376360" y="3529080"/>
              <a:ext cx="27612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"/>
            <p:cNvSpPr/>
            <p:nvPr/>
          </p:nvSpPr>
          <p:spPr>
            <a:xfrm>
              <a:off x="2376360" y="3690720"/>
              <a:ext cx="0" cy="14292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"/>
            <p:cNvSpPr/>
            <p:nvPr/>
          </p:nvSpPr>
          <p:spPr>
            <a:xfrm>
              <a:off x="2376360" y="3833640"/>
              <a:ext cx="10476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"/>
            <p:cNvSpPr/>
            <p:nvPr/>
          </p:nvSpPr>
          <p:spPr>
            <a:xfrm flipV="1">
              <a:off x="2481120" y="3728520"/>
              <a:ext cx="0" cy="10476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"/>
            <p:cNvSpPr/>
            <p:nvPr/>
          </p:nvSpPr>
          <p:spPr>
            <a:xfrm>
              <a:off x="2481120" y="3728880"/>
              <a:ext cx="8568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"/>
            <p:cNvSpPr/>
            <p:nvPr/>
          </p:nvSpPr>
          <p:spPr>
            <a:xfrm>
              <a:off x="2481120" y="3833640"/>
              <a:ext cx="0" cy="10476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"/>
            <p:cNvSpPr/>
            <p:nvPr/>
          </p:nvSpPr>
          <p:spPr>
            <a:xfrm>
              <a:off x="2481120" y="3938400"/>
              <a:ext cx="17136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"/>
            <p:cNvSpPr/>
            <p:nvPr/>
          </p:nvSpPr>
          <p:spPr>
            <a:xfrm>
              <a:off x="2185920" y="3681360"/>
              <a:ext cx="0" cy="56196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"/>
            <p:cNvSpPr/>
            <p:nvPr/>
          </p:nvSpPr>
          <p:spPr>
            <a:xfrm>
              <a:off x="2185920" y="4243320"/>
              <a:ext cx="29520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"/>
            <p:cNvSpPr/>
            <p:nvPr/>
          </p:nvSpPr>
          <p:spPr>
            <a:xfrm flipV="1">
              <a:off x="2481120" y="4138200"/>
              <a:ext cx="0" cy="10476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"/>
            <p:cNvSpPr/>
            <p:nvPr/>
          </p:nvSpPr>
          <p:spPr>
            <a:xfrm>
              <a:off x="2481120" y="4138560"/>
              <a:ext cx="21888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"/>
            <p:cNvSpPr/>
            <p:nvPr/>
          </p:nvSpPr>
          <p:spPr>
            <a:xfrm>
              <a:off x="2481120" y="4243320"/>
              <a:ext cx="0" cy="950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"/>
            <p:cNvSpPr/>
            <p:nvPr/>
          </p:nvSpPr>
          <p:spPr>
            <a:xfrm>
              <a:off x="2481120" y="4338360"/>
              <a:ext cx="13320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"/>
            <p:cNvSpPr/>
            <p:nvPr/>
          </p:nvSpPr>
          <p:spPr>
            <a:xfrm>
              <a:off x="2166840" y="4290840"/>
              <a:ext cx="0" cy="6476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"/>
            <p:cNvSpPr/>
            <p:nvPr/>
          </p:nvSpPr>
          <p:spPr>
            <a:xfrm>
              <a:off x="2166840" y="4938480"/>
              <a:ext cx="8568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"/>
            <p:cNvSpPr/>
            <p:nvPr/>
          </p:nvSpPr>
          <p:spPr>
            <a:xfrm flipV="1">
              <a:off x="2252520" y="4709520"/>
              <a:ext cx="0" cy="22860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"/>
            <p:cNvSpPr/>
            <p:nvPr/>
          </p:nvSpPr>
          <p:spPr>
            <a:xfrm>
              <a:off x="2252520" y="4709880"/>
              <a:ext cx="18072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"/>
            <p:cNvSpPr/>
            <p:nvPr/>
          </p:nvSpPr>
          <p:spPr>
            <a:xfrm flipV="1">
              <a:off x="2433240" y="4547880"/>
              <a:ext cx="0" cy="1616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"/>
            <p:cNvSpPr/>
            <p:nvPr/>
          </p:nvSpPr>
          <p:spPr>
            <a:xfrm>
              <a:off x="2433240" y="4548240"/>
              <a:ext cx="18108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"/>
            <p:cNvSpPr/>
            <p:nvPr/>
          </p:nvSpPr>
          <p:spPr>
            <a:xfrm>
              <a:off x="2433240" y="4709880"/>
              <a:ext cx="0" cy="14292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"/>
            <p:cNvSpPr/>
            <p:nvPr/>
          </p:nvSpPr>
          <p:spPr>
            <a:xfrm>
              <a:off x="2433240" y="4852800"/>
              <a:ext cx="2880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"/>
            <p:cNvSpPr/>
            <p:nvPr/>
          </p:nvSpPr>
          <p:spPr>
            <a:xfrm flipV="1">
              <a:off x="2462040" y="4747680"/>
              <a:ext cx="0" cy="10476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"/>
            <p:cNvSpPr/>
            <p:nvPr/>
          </p:nvSpPr>
          <p:spPr>
            <a:xfrm>
              <a:off x="2462040" y="4748040"/>
              <a:ext cx="15228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"/>
            <p:cNvSpPr/>
            <p:nvPr/>
          </p:nvSpPr>
          <p:spPr>
            <a:xfrm>
              <a:off x="2462040" y="4852800"/>
              <a:ext cx="0" cy="9540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"/>
            <p:cNvSpPr/>
            <p:nvPr/>
          </p:nvSpPr>
          <p:spPr>
            <a:xfrm>
              <a:off x="2462040" y="4948200"/>
              <a:ext cx="14292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"/>
            <p:cNvSpPr/>
            <p:nvPr/>
          </p:nvSpPr>
          <p:spPr>
            <a:xfrm>
              <a:off x="2252520" y="4938480"/>
              <a:ext cx="0" cy="31428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"/>
            <p:cNvSpPr/>
            <p:nvPr/>
          </p:nvSpPr>
          <p:spPr>
            <a:xfrm>
              <a:off x="2252520" y="5252760"/>
              <a:ext cx="58104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"/>
            <p:cNvSpPr/>
            <p:nvPr/>
          </p:nvSpPr>
          <p:spPr>
            <a:xfrm flipV="1">
              <a:off x="2833560" y="5157720"/>
              <a:ext cx="0" cy="950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"/>
            <p:cNvSpPr/>
            <p:nvPr/>
          </p:nvSpPr>
          <p:spPr>
            <a:xfrm>
              <a:off x="2833560" y="5157720"/>
              <a:ext cx="12384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"/>
            <p:cNvSpPr/>
            <p:nvPr/>
          </p:nvSpPr>
          <p:spPr>
            <a:xfrm>
              <a:off x="2833560" y="5252760"/>
              <a:ext cx="0" cy="10512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"/>
            <p:cNvSpPr/>
            <p:nvPr/>
          </p:nvSpPr>
          <p:spPr>
            <a:xfrm>
              <a:off x="2833560" y="5357880"/>
              <a:ext cx="19980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"/>
            <p:cNvSpPr/>
            <p:nvPr/>
          </p:nvSpPr>
          <p:spPr>
            <a:xfrm>
              <a:off x="2138040" y="4795560"/>
              <a:ext cx="0" cy="86688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"/>
            <p:cNvSpPr/>
            <p:nvPr/>
          </p:nvSpPr>
          <p:spPr>
            <a:xfrm>
              <a:off x="2138040" y="5662440"/>
              <a:ext cx="63828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"/>
            <p:cNvSpPr/>
            <p:nvPr/>
          </p:nvSpPr>
          <p:spPr>
            <a:xfrm flipV="1">
              <a:off x="2776320" y="5557320"/>
              <a:ext cx="0" cy="10476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"/>
            <p:cNvSpPr/>
            <p:nvPr/>
          </p:nvSpPr>
          <p:spPr>
            <a:xfrm>
              <a:off x="2776320" y="5557680"/>
              <a:ext cx="14292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"/>
            <p:cNvSpPr/>
            <p:nvPr/>
          </p:nvSpPr>
          <p:spPr>
            <a:xfrm>
              <a:off x="2776320" y="5662440"/>
              <a:ext cx="0" cy="10476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"/>
            <p:cNvSpPr/>
            <p:nvPr/>
          </p:nvSpPr>
          <p:spPr>
            <a:xfrm>
              <a:off x="2776320" y="5767200"/>
              <a:ext cx="19044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"/>
            <p:cNvSpPr/>
            <p:nvPr/>
          </p:nvSpPr>
          <p:spPr>
            <a:xfrm>
              <a:off x="1290240" y="4976640"/>
              <a:ext cx="0" cy="11048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"/>
            <p:cNvSpPr/>
            <p:nvPr/>
          </p:nvSpPr>
          <p:spPr>
            <a:xfrm>
              <a:off x="1290240" y="6081480"/>
              <a:ext cx="43848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"/>
            <p:cNvSpPr/>
            <p:nvPr/>
          </p:nvSpPr>
          <p:spPr>
            <a:xfrm flipV="1">
              <a:off x="1728720" y="6005160"/>
              <a:ext cx="0" cy="7596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"/>
            <p:cNvSpPr/>
            <p:nvPr/>
          </p:nvSpPr>
          <p:spPr>
            <a:xfrm>
              <a:off x="1728720" y="6005520"/>
              <a:ext cx="24732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"/>
            <p:cNvSpPr/>
            <p:nvPr/>
          </p:nvSpPr>
          <p:spPr>
            <a:xfrm flipV="1">
              <a:off x="1976040" y="5967360"/>
              <a:ext cx="0" cy="3816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"/>
            <p:cNvSpPr/>
            <p:nvPr/>
          </p:nvSpPr>
          <p:spPr>
            <a:xfrm>
              <a:off x="1976040" y="5967360"/>
              <a:ext cx="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"/>
            <p:cNvSpPr/>
            <p:nvPr/>
          </p:nvSpPr>
          <p:spPr>
            <a:xfrm>
              <a:off x="1976040" y="6005520"/>
              <a:ext cx="0" cy="1616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"/>
            <p:cNvSpPr/>
            <p:nvPr/>
          </p:nvSpPr>
          <p:spPr>
            <a:xfrm>
              <a:off x="1976040" y="6167160"/>
              <a:ext cx="210528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"/>
            <p:cNvSpPr/>
            <p:nvPr/>
          </p:nvSpPr>
          <p:spPr>
            <a:xfrm>
              <a:off x="1728720" y="6081480"/>
              <a:ext cx="0" cy="29556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"/>
            <p:cNvSpPr/>
            <p:nvPr/>
          </p:nvSpPr>
          <p:spPr>
            <a:xfrm>
              <a:off x="1728720" y="6377040"/>
              <a:ext cx="255240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"/>
            <p:cNvSpPr/>
            <p:nvPr/>
          </p:nvSpPr>
          <p:spPr>
            <a:xfrm>
              <a:off x="3848400" y="614160"/>
              <a:ext cx="653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Os11g3954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"/>
            <p:cNvSpPr/>
            <p:nvPr/>
          </p:nvSpPr>
          <p:spPr>
            <a:xfrm>
              <a:off x="3304080" y="814320"/>
              <a:ext cx="596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Bd4g1397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"/>
            <p:cNvSpPr/>
            <p:nvPr/>
          </p:nvSpPr>
          <p:spPr>
            <a:xfrm>
              <a:off x="2011320" y="1014480"/>
              <a:ext cx="575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At1g3476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"/>
            <p:cNvSpPr/>
            <p:nvPr/>
          </p:nvSpPr>
          <p:spPr>
            <a:xfrm>
              <a:off x="2049480" y="1224000"/>
              <a:ext cx="575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At1g2648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"/>
            <p:cNvSpPr/>
            <p:nvPr/>
          </p:nvSpPr>
          <p:spPr>
            <a:xfrm>
              <a:off x="2253960" y="1423800"/>
              <a:ext cx="10098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At2g42590_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GRF9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"/>
            <p:cNvSpPr/>
            <p:nvPr/>
          </p:nvSpPr>
          <p:spPr>
            <a:xfrm>
              <a:off x="3181680" y="1623960"/>
              <a:ext cx="653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Os01g1111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"/>
            <p:cNvSpPr/>
            <p:nvPr/>
          </p:nvSpPr>
          <p:spPr>
            <a:xfrm>
              <a:off x="2667240" y="1833480"/>
              <a:ext cx="653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Os02g3697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"/>
            <p:cNvSpPr/>
            <p:nvPr/>
          </p:nvSpPr>
          <p:spPr>
            <a:xfrm>
              <a:off x="2799360" y="2033640"/>
              <a:ext cx="596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Bd3g4696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"/>
            <p:cNvSpPr/>
            <p:nvPr/>
          </p:nvSpPr>
          <p:spPr>
            <a:xfrm>
              <a:off x="2676960" y="2233440"/>
              <a:ext cx="653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Os04g3887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"/>
            <p:cNvSpPr/>
            <p:nvPr/>
          </p:nvSpPr>
          <p:spPr>
            <a:xfrm>
              <a:off x="2666160" y="2442960"/>
              <a:ext cx="596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Bd5g1251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"/>
            <p:cNvSpPr/>
            <p:nvPr/>
          </p:nvSpPr>
          <p:spPr>
            <a:xfrm>
              <a:off x="2585160" y="2643120"/>
              <a:ext cx="12488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Os08g33370 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OsGF14c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"/>
            <p:cNvSpPr/>
            <p:nvPr/>
          </p:nvSpPr>
          <p:spPr>
            <a:xfrm>
              <a:off x="2637360" y="2852640"/>
              <a:ext cx="596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Bd3g3648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"/>
            <p:cNvSpPr/>
            <p:nvPr/>
          </p:nvSpPr>
          <p:spPr>
            <a:xfrm>
              <a:off x="2657880" y="3052800"/>
              <a:ext cx="653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Os03g5029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"/>
            <p:cNvSpPr/>
            <p:nvPr/>
          </p:nvSpPr>
          <p:spPr>
            <a:xfrm>
              <a:off x="2656440" y="3252600"/>
              <a:ext cx="596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Bd1g1129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"/>
            <p:cNvSpPr/>
            <p:nvPr/>
          </p:nvSpPr>
          <p:spPr>
            <a:xfrm>
              <a:off x="2697120" y="3462120"/>
              <a:ext cx="575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At5g3848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"/>
            <p:cNvSpPr/>
            <p:nvPr/>
          </p:nvSpPr>
          <p:spPr>
            <a:xfrm>
              <a:off x="2621160" y="3662280"/>
              <a:ext cx="575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At3g0252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"/>
            <p:cNvSpPr/>
            <p:nvPr/>
          </p:nvSpPr>
          <p:spPr>
            <a:xfrm>
              <a:off x="2698560" y="3862440"/>
              <a:ext cx="9457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At5g16050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GRF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"/>
            <p:cNvSpPr/>
            <p:nvPr/>
          </p:nvSpPr>
          <p:spPr>
            <a:xfrm>
              <a:off x="2772000" y="4071960"/>
              <a:ext cx="653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Os11g3445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"/>
            <p:cNvSpPr/>
            <p:nvPr/>
          </p:nvSpPr>
          <p:spPr>
            <a:xfrm>
              <a:off x="2666160" y="4271760"/>
              <a:ext cx="596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Bd4g1664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"/>
            <p:cNvSpPr/>
            <p:nvPr/>
          </p:nvSpPr>
          <p:spPr>
            <a:xfrm>
              <a:off x="2668680" y="4471920"/>
              <a:ext cx="575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At1g783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"/>
            <p:cNvSpPr/>
            <p:nvPr/>
          </p:nvSpPr>
          <p:spPr>
            <a:xfrm>
              <a:off x="2659320" y="4681440"/>
              <a:ext cx="575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At4g090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" name=""/>
            <p:cNvSpPr/>
            <p:nvPr/>
          </p:nvSpPr>
          <p:spPr>
            <a:xfrm>
              <a:off x="2649600" y="4881600"/>
              <a:ext cx="575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At1g3516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" name=""/>
            <p:cNvSpPr/>
            <p:nvPr/>
          </p:nvSpPr>
          <p:spPr>
            <a:xfrm>
              <a:off x="3029040" y="5081400"/>
              <a:ext cx="653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Os08g3749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"/>
            <p:cNvSpPr/>
            <p:nvPr/>
          </p:nvSpPr>
          <p:spPr>
            <a:xfrm>
              <a:off x="3094560" y="5290920"/>
              <a:ext cx="596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Bd3g3864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" name=""/>
            <p:cNvSpPr/>
            <p:nvPr/>
          </p:nvSpPr>
          <p:spPr>
            <a:xfrm>
              <a:off x="2963880" y="5491080"/>
              <a:ext cx="575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At5g6543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"/>
            <p:cNvSpPr/>
            <p:nvPr/>
          </p:nvSpPr>
          <p:spPr>
            <a:xfrm>
              <a:off x="3011400" y="5691240"/>
              <a:ext cx="575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At5g1045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"/>
            <p:cNvSpPr/>
            <p:nvPr/>
          </p:nvSpPr>
          <p:spPr>
            <a:xfrm>
              <a:off x="2030400" y="5900760"/>
              <a:ext cx="575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At1g223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" name=""/>
            <p:cNvSpPr/>
            <p:nvPr/>
          </p:nvSpPr>
          <p:spPr>
            <a:xfrm>
              <a:off x="4125960" y="6100560"/>
              <a:ext cx="575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At1g2229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"/>
            <p:cNvSpPr/>
            <p:nvPr/>
          </p:nvSpPr>
          <p:spPr>
            <a:xfrm>
              <a:off x="4335480" y="6300720"/>
              <a:ext cx="575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At1g7822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82" name=""/>
          <p:cNvSpPr/>
          <p:nvPr/>
        </p:nvSpPr>
        <p:spPr>
          <a:xfrm>
            <a:off x="2209320" y="3033720"/>
            <a:ext cx="3726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"/>
          <p:cNvSpPr/>
          <p:nvPr/>
        </p:nvSpPr>
        <p:spPr>
          <a:xfrm>
            <a:off x="2169360" y="4049640"/>
            <a:ext cx="3726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"/>
          <p:cNvSpPr/>
          <p:nvPr/>
        </p:nvSpPr>
        <p:spPr>
          <a:xfrm>
            <a:off x="2214000" y="2779560"/>
            <a:ext cx="308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99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"/>
          <p:cNvSpPr/>
          <p:nvPr/>
        </p:nvSpPr>
        <p:spPr>
          <a:xfrm>
            <a:off x="2210760" y="1890720"/>
            <a:ext cx="3726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"/>
          <p:cNvSpPr/>
          <p:nvPr/>
        </p:nvSpPr>
        <p:spPr>
          <a:xfrm>
            <a:off x="2509200" y="5065560"/>
            <a:ext cx="3726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"/>
          <p:cNvSpPr/>
          <p:nvPr/>
        </p:nvSpPr>
        <p:spPr>
          <a:xfrm>
            <a:off x="2191680" y="4519440"/>
            <a:ext cx="308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99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"/>
          <p:cNvSpPr/>
          <p:nvPr/>
        </p:nvSpPr>
        <p:spPr>
          <a:xfrm>
            <a:off x="2623680" y="611280"/>
            <a:ext cx="3726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"/>
          <p:cNvSpPr/>
          <p:nvPr/>
        </p:nvSpPr>
        <p:spPr>
          <a:xfrm>
            <a:off x="1468080" y="5884920"/>
            <a:ext cx="308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97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"/>
          <p:cNvSpPr/>
          <p:nvPr/>
        </p:nvSpPr>
        <p:spPr>
          <a:xfrm>
            <a:off x="1826640" y="4605480"/>
            <a:ext cx="3726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"/>
          <p:cNvSpPr/>
          <p:nvPr/>
        </p:nvSpPr>
        <p:spPr>
          <a:xfrm>
            <a:off x="2451960" y="5478480"/>
            <a:ext cx="3726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"/>
          <p:cNvSpPr/>
          <p:nvPr/>
        </p:nvSpPr>
        <p:spPr>
          <a:xfrm>
            <a:off x="5724360" y="907920"/>
            <a:ext cx="2592720" cy="1292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At = Arabidopsi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Os = Ric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Bd = Brachypodiu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Bootstrap support of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≥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90% show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1000 dataset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"/>
          <p:cNvSpPr/>
          <p:nvPr/>
        </p:nvSpPr>
        <p:spPr>
          <a:xfrm>
            <a:off x="4276800" y="1844640"/>
            <a:ext cx="9360" cy="3975120"/>
          </a:xfrm>
          <a:custGeom>
            <a:avLst/>
            <a:gdLst/>
            <a:ahLst/>
            <a:rect l="l" t="t" r="r" b="b"/>
            <a:pathLst>
              <a:path w="6" h="2504">
                <a:moveTo>
                  <a:pt x="5" y="0"/>
                </a:moveTo>
                <a:lnTo>
                  <a:pt x="0" y="2"/>
                </a:lnTo>
                <a:lnTo>
                  <a:pt x="6" y="2504"/>
                </a:lnTo>
              </a:path>
            </a:pathLst>
          </a:custGeom>
          <a:noFill/>
          <a:ln w="255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"/>
          <p:cNvSpPr/>
          <p:nvPr/>
        </p:nvSpPr>
        <p:spPr>
          <a:xfrm>
            <a:off x="4427640" y="3429000"/>
            <a:ext cx="230508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14-3-3 clade selected for tree in figure 9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"/>
          <p:cNvSpPr/>
          <p:nvPr/>
        </p:nvSpPr>
        <p:spPr>
          <a:xfrm>
            <a:off x="3995640" y="1844640"/>
            <a:ext cx="28908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"/>
          <p:cNvSpPr/>
          <p:nvPr/>
        </p:nvSpPr>
        <p:spPr>
          <a:xfrm>
            <a:off x="3995640" y="5805360"/>
            <a:ext cx="28908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9-25T14:32:17Z</dcterms:created>
  <dc:creator>Janet Higgins</dc:creator>
  <dc:description/>
  <dc:language>en-US</dc:language>
  <cp:lastModifiedBy>Janet Higgins</cp:lastModifiedBy>
  <dcterms:modified xsi:type="dcterms:W3CDTF">2010-01-06T12:04:25Z</dcterms:modified>
  <cp:revision>10</cp:revision>
  <dc:subject/>
  <dc:title>Slide 1</dc:title>
</cp:coreProperties>
</file>